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F5F28-4B68-4CDE-AF64-FE173F7535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BA4F3-FA46-421E-B298-CA54742ECD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BAC8A-6271-4EA3-A6E2-F230DDC7BC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92665-41C1-41BC-9FDF-4194DEA71A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5CDF6-F7A6-46AB-9CC2-F3CD5E1AD8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08D78-B4F6-4FC8-8C33-FCAEFDE92E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3E4CA-2A44-4518-9455-0BE1ABD7EE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C12AB-ECF3-4DB9-A1B7-C66D2558FB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5322C-5B28-49E7-9465-CA30CC593F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C4C250-D89E-42D1-8861-51620D35E5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580C4-61B2-4D90-9980-8DDDABDC4F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6AC14-45CE-4031-847B-95895A6036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4FDA2C8-D427-4023-89D4-2F9F70DED437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CD9D614-BF19-412F-9721-5828A653BFA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15920" y="638280"/>
            <a:ext cx="674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1. Dendrite defects in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n-44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utants at early stages of development.</a:t>
            </a: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35080" y="1414440"/>
          <a:ext cx="6240240" cy="622440"/>
        </p:xfrm>
        <a:graphic>
          <a:graphicData uri="http://schemas.openxmlformats.org/drawingml/2006/table">
            <a:tbl>
              <a:tblPr/>
              <a:tblGrid>
                <a:gridCol w="1068120"/>
                <a:gridCol w="1059120"/>
                <a:gridCol w="822240"/>
                <a:gridCol w="822240"/>
                <a:gridCol w="822240"/>
                <a:gridCol w="1046160"/>
                <a:gridCol w="600120"/>
              </a:tblGrid>
              <a:tr h="177120"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centage dendrite phenotype (following axon emergence) at 7-7.5hrs post-hatc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8320"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otyp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rm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hor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se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eri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tra Proces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8320"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yIs417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wild-typ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7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8680"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44(n179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800" marR="108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9T00:25:21Z</dcterms:created>
  <dc:creator>Leonie Kirszenblat</dc:creator>
  <dc:description/>
  <dc:language>en-US</dc:language>
  <cp:lastModifiedBy>Massimo Hilliard - Mobile</cp:lastModifiedBy>
  <dcterms:modified xsi:type="dcterms:W3CDTF">2011-02-09T07:03:09Z</dcterms:modified>
  <cp:revision>28</cp:revision>
  <dc:subject/>
  <dc:title>Slide 1</dc:title>
</cp:coreProperties>
</file>